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2A3108-AF8D-416F-99BD-E97F02352F0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6DFD1-6B26-4528-917C-4A32E6DAEC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C88AB8-85A1-4CB1-990A-020A36A7705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94B654-6120-4A75-876A-897893C1D0D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E04E25-2307-47FC-8995-C6F76E216F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586D82-77FD-45FB-BA56-D77766E323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4CBD41-B91E-4968-8346-59C7397052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B48D4C-0AC4-489C-B97F-4DF5886331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27040"/>
            <a:ext cx="5914800" cy="887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CF6B57-34F3-4314-B045-091CCD94E4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CA693D-A586-4C84-A910-723B67817A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014DF0-2025-4D86-B2C9-8427140EF2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D95430-3C5F-4DB1-A76A-879EF48D32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A663A6-CA4C-427E-B207-04CE2EDF32C4}" type="slidenum">
              <a:rPr b="0" lang="en-US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図 4" descr=""/>
          <p:cNvPicPr/>
          <p:nvPr/>
        </p:nvPicPr>
        <p:blipFill>
          <a:blip r:embed="rId1"/>
          <a:stretch/>
        </p:blipFill>
        <p:spPr>
          <a:xfrm>
            <a:off x="0" y="3373560"/>
            <a:ext cx="6858000" cy="3887640"/>
          </a:xfrm>
          <a:prstGeom prst="rect">
            <a:avLst/>
          </a:prstGeom>
          <a:ln w="0">
            <a:noFill/>
          </a:ln>
        </p:spPr>
      </p:pic>
      <p:sp>
        <p:nvSpPr>
          <p:cNvPr id="42" name="テキスト ボックス 5"/>
          <p:cNvSpPr/>
          <p:nvPr/>
        </p:nvSpPr>
        <p:spPr>
          <a:xfrm>
            <a:off x="2482920" y="2900520"/>
            <a:ext cx="4316400" cy="428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  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pGSU10-3-1 (159,072 bp in size) is </a:t>
            </a:r>
            <a:r>
              <a:rPr b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Inc A/C2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replicon plasmid, and carries </a:t>
            </a:r>
            <a:r>
              <a:rPr b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class 1 integron [</a:t>
            </a:r>
            <a:r>
              <a:rPr b="1" i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intI1, dfrA12</a:t>
            </a:r>
            <a:r>
              <a:rPr b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, </a:t>
            </a:r>
            <a:r>
              <a:rPr b="1" i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aadA2</a:t>
            </a:r>
            <a:r>
              <a:rPr b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, </a:t>
            </a:r>
            <a:r>
              <a:rPr b="1" i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qacE∆1</a:t>
            </a:r>
            <a:r>
              <a:rPr b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, sul1], </a:t>
            </a:r>
            <a:r>
              <a:rPr b="1" i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qnrA1</a:t>
            </a:r>
            <a:r>
              <a:rPr b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, </a:t>
            </a:r>
            <a:r>
              <a:rPr b="1" i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aac(3)-IId</a:t>
            </a:r>
            <a:r>
              <a:rPr b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, </a:t>
            </a:r>
            <a:r>
              <a:rPr b="1" i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bla</a:t>
            </a:r>
            <a:r>
              <a:rPr b="1" lang="en-US" sz="700" spc="-1" strike="noStrike" baseline="-25000">
                <a:solidFill>
                  <a:srgbClr val="ff0000"/>
                </a:solidFill>
                <a:latin typeface="Arial"/>
                <a:ea typeface="Arial"/>
              </a:rPr>
              <a:t>TEM-1B</a:t>
            </a:r>
            <a:r>
              <a:rPr b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, </a:t>
            </a:r>
            <a:r>
              <a:rPr b="1" i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aph(6)-Id</a:t>
            </a:r>
            <a:r>
              <a:rPr b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, </a:t>
            </a:r>
            <a:r>
              <a:rPr b="1" i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aph(3'')-Ib</a:t>
            </a:r>
            <a:r>
              <a:rPr b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, </a:t>
            </a:r>
            <a:r>
              <a:rPr b="1" i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sul2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and multiple ISs (IS</a:t>
            </a:r>
            <a:r>
              <a:rPr b="0" i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91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family, three IS</a:t>
            </a:r>
            <a:r>
              <a:rPr b="0" i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26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, IS</a:t>
            </a:r>
            <a:r>
              <a:rPr b="0" i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Ehe3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, IS</a:t>
            </a:r>
            <a:r>
              <a:rPr b="0" i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903D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, IS</a:t>
            </a:r>
            <a:r>
              <a:rPr b="0" i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1182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 family). 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図 7" descr=""/>
          <p:cNvPicPr/>
          <p:nvPr/>
        </p:nvPicPr>
        <p:blipFill>
          <a:blip r:embed="rId2"/>
          <a:stretch/>
        </p:blipFill>
        <p:spPr>
          <a:xfrm flipH="1" rot="10800000">
            <a:off x="14400" y="3316320"/>
            <a:ext cx="2141280" cy="84240"/>
          </a:xfrm>
          <a:prstGeom prst="rect">
            <a:avLst/>
          </a:prstGeom>
          <a:ln w="0">
            <a:noFill/>
          </a:ln>
        </p:spPr>
      </p:pic>
      <p:sp>
        <p:nvSpPr>
          <p:cNvPr id="44" name="正方形/長方形 8"/>
          <p:cNvSpPr/>
          <p:nvPr/>
        </p:nvSpPr>
        <p:spPr>
          <a:xfrm>
            <a:off x="182520" y="2643120"/>
            <a:ext cx="1452600" cy="27684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class 1 integron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[</a:t>
            </a:r>
            <a:r>
              <a:rPr b="0" i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intI1, dfrA12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, </a:t>
            </a:r>
            <a:r>
              <a:rPr b="0" i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aadA2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, </a:t>
            </a:r>
            <a:r>
              <a:rPr b="0" i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qacE∆1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, sul1]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5" name="直線矢印コネクタ 11"/>
          <p:cNvCxnSpPr/>
          <p:nvPr/>
        </p:nvCxnSpPr>
        <p:spPr>
          <a:xfrm>
            <a:off x="1923840" y="3137040"/>
            <a:ext cx="1080" cy="180000"/>
          </a:xfrm>
          <a:prstGeom prst="straightConnector1">
            <a:avLst/>
          </a:prstGeom>
          <a:ln w="648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46" name="直線矢印コネクタ 12"/>
          <p:cNvCxnSpPr/>
          <p:nvPr/>
        </p:nvCxnSpPr>
        <p:spPr>
          <a:xfrm>
            <a:off x="966960" y="2898720"/>
            <a:ext cx="791280" cy="426240"/>
          </a:xfrm>
          <a:prstGeom prst="straightConnector1">
            <a:avLst/>
          </a:prstGeom>
          <a:ln w="648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47" name="テキスト ボックス 9"/>
          <p:cNvSpPr/>
          <p:nvPr/>
        </p:nvSpPr>
        <p:spPr>
          <a:xfrm>
            <a:off x="1087200" y="2978280"/>
            <a:ext cx="1368720" cy="198000"/>
          </a:xfrm>
          <a:prstGeom prst="rect">
            <a:avLst/>
          </a:prstGeom>
          <a:solidFill>
            <a:srgbClr val="ffffff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bla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TEM-1B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, </a:t>
            </a:r>
            <a:r>
              <a:rPr b="0" i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aph(6)-Id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, </a:t>
            </a:r>
            <a:r>
              <a:rPr b="0" i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aph(3'')-Ib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, </a:t>
            </a:r>
            <a:r>
              <a:rPr b="0" i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sul2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正方形/長方形 15"/>
          <p:cNvSpPr/>
          <p:nvPr/>
        </p:nvSpPr>
        <p:spPr>
          <a:xfrm>
            <a:off x="38160" y="2089080"/>
            <a:ext cx="178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. S1A. pGSU10-3-1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図 4" descr=""/>
          <p:cNvPicPr/>
          <p:nvPr/>
        </p:nvPicPr>
        <p:blipFill>
          <a:blip r:embed="rId1"/>
          <a:stretch/>
        </p:blipFill>
        <p:spPr>
          <a:xfrm>
            <a:off x="0" y="3397320"/>
            <a:ext cx="6858000" cy="3765600"/>
          </a:xfrm>
          <a:prstGeom prst="rect">
            <a:avLst/>
          </a:prstGeom>
          <a:ln w="0">
            <a:noFill/>
          </a:ln>
        </p:spPr>
      </p:pic>
      <p:pic>
        <p:nvPicPr>
          <p:cNvPr id="50" name="図 6" descr=""/>
          <p:cNvPicPr/>
          <p:nvPr/>
        </p:nvPicPr>
        <p:blipFill>
          <a:blip r:embed="rId2"/>
          <a:stretch/>
        </p:blipFill>
        <p:spPr>
          <a:xfrm>
            <a:off x="12600" y="3295800"/>
            <a:ext cx="2059200" cy="136440"/>
          </a:xfrm>
          <a:prstGeom prst="rect">
            <a:avLst/>
          </a:prstGeom>
          <a:ln w="0">
            <a:noFill/>
          </a:ln>
        </p:spPr>
      </p:pic>
      <p:sp>
        <p:nvSpPr>
          <p:cNvPr id="51" name="テキスト ボックス 7"/>
          <p:cNvSpPr/>
          <p:nvPr/>
        </p:nvSpPr>
        <p:spPr>
          <a:xfrm>
            <a:off x="2441520" y="2909880"/>
            <a:ext cx="4467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   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pGSU10-3-2 (134,879 bp in size) is </a:t>
            </a:r>
            <a:r>
              <a:rPr b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IncFII(K)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 replicon plasmid, and carries </a:t>
            </a:r>
            <a:r>
              <a:rPr b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IS</a:t>
            </a:r>
            <a:r>
              <a:rPr b="1" i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26</a:t>
            </a:r>
            <a:r>
              <a:rPr b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-mediated ARGs [</a:t>
            </a:r>
            <a:r>
              <a:rPr b="1" i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aac(6')Ib-cr, blaOXA-1, catB4 </a:t>
            </a:r>
            <a:r>
              <a:rPr b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(truncated), </a:t>
            </a:r>
            <a:r>
              <a:rPr b="1" i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aac(3)-IId</a:t>
            </a:r>
            <a:r>
              <a:rPr b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], </a:t>
            </a:r>
            <a:r>
              <a:rPr b="1" i="1" lang="en-US" sz="700" spc="-1" strike="noStrike">
                <a:solidFill>
                  <a:srgbClr val="ff0000"/>
                </a:solidFill>
                <a:latin typeface="Arial"/>
                <a:ea typeface="Arial"/>
              </a:rPr>
              <a:t>tet(A)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and copper/arsenate resistance locus. 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正方形/長方形 9"/>
          <p:cNvSpPr/>
          <p:nvPr/>
        </p:nvSpPr>
        <p:spPr>
          <a:xfrm>
            <a:off x="479160" y="2619360"/>
            <a:ext cx="356040" cy="16992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  <a:ea typeface="Arial"/>
              </a:rPr>
              <a:t>tet(A)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3" name="直線矢印コネクタ 10"/>
          <p:cNvCxnSpPr/>
          <p:nvPr/>
        </p:nvCxnSpPr>
        <p:spPr>
          <a:xfrm>
            <a:off x="628560" y="2768760"/>
            <a:ext cx="465840" cy="527760"/>
          </a:xfrm>
          <a:prstGeom prst="straightConnector1">
            <a:avLst/>
          </a:prstGeom>
          <a:ln w="648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54" name="直線矢印コネクタ 12"/>
          <p:cNvCxnSpPr/>
          <p:nvPr/>
        </p:nvCxnSpPr>
        <p:spPr>
          <a:xfrm>
            <a:off x="1190160" y="3115800"/>
            <a:ext cx="1080" cy="180360"/>
          </a:xfrm>
          <a:prstGeom prst="straightConnector1">
            <a:avLst/>
          </a:prstGeom>
          <a:ln w="648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55" name="正方形/長方形 8"/>
          <p:cNvSpPr/>
          <p:nvPr/>
        </p:nvSpPr>
        <p:spPr>
          <a:xfrm>
            <a:off x="628560" y="2890800"/>
            <a:ext cx="1517760" cy="245880"/>
          </a:xfrm>
          <a:prstGeom prst="rect">
            <a:avLst/>
          </a:prstGeom>
          <a:solidFill>
            <a:srgbClr val="ffffff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Arial"/>
              </a:rPr>
              <a:t>IS</a:t>
            </a:r>
            <a:r>
              <a:rPr b="0" i="1" lang="en-US" sz="500" spc="-1" strike="noStrike">
                <a:solidFill>
                  <a:srgbClr val="000000"/>
                </a:solidFill>
                <a:latin typeface="Arial"/>
                <a:ea typeface="Arial"/>
              </a:rPr>
              <a:t>26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  <a:ea typeface="Arial"/>
              </a:rPr>
              <a:t>-mediated ARGs [</a:t>
            </a:r>
            <a:r>
              <a:rPr b="0" i="1" lang="en-US" sz="500" spc="-1" strike="noStrike">
                <a:solidFill>
                  <a:srgbClr val="000000"/>
                </a:solidFill>
                <a:latin typeface="Arial"/>
                <a:ea typeface="Arial"/>
              </a:rPr>
              <a:t>aac(6')Ib-cr, blaOXA-1, catB4 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  <a:ea typeface="Arial"/>
              </a:rPr>
              <a:t>(truncated), </a:t>
            </a:r>
            <a:r>
              <a:rPr b="0" i="1" lang="en-US" sz="500" spc="-1" strike="noStrike">
                <a:solidFill>
                  <a:srgbClr val="000000"/>
                </a:solidFill>
                <a:latin typeface="Arial"/>
                <a:ea typeface="Arial"/>
              </a:rPr>
              <a:t>aac(3)-IId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  <a:ea typeface="Arial"/>
              </a:rPr>
              <a:t>], 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正方形/長方形 13"/>
          <p:cNvSpPr/>
          <p:nvPr/>
        </p:nvSpPr>
        <p:spPr>
          <a:xfrm>
            <a:off x="50040" y="2149560"/>
            <a:ext cx="178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. S1B. pGSU10-3-2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正方形/長方形 6"/>
          <p:cNvSpPr/>
          <p:nvPr/>
        </p:nvSpPr>
        <p:spPr>
          <a:xfrm>
            <a:off x="2452680" y="2921040"/>
            <a:ext cx="3429000" cy="32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 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GSU10-3-3 (66.2 kb in size) carries </a:t>
            </a:r>
            <a:r>
              <a:rPr b="1" i="1" lang="en-US" sz="7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bla</a:t>
            </a:r>
            <a:r>
              <a:rPr b="1" lang="en-US" sz="700" spc="-1" strike="noStrike" baseline="-25000">
                <a:solidFill>
                  <a:srgbClr val="ff0000"/>
                </a:solidFill>
                <a:latin typeface="Arial"/>
                <a:ea typeface="ＭＳ Ｐゴシック"/>
              </a:rPr>
              <a:t>KPC-2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and </a:t>
            </a:r>
            <a:r>
              <a:rPr b="1" i="1" lang="en-US" sz="7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fosA3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, and is relatively shorter size in </a:t>
            </a:r>
            <a:r>
              <a:rPr b="1" lang="en-US" sz="7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IncFII(pHN7A8)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eplicon compared with other KPC-2 plasmids</a:t>
            </a:r>
            <a:r>
              <a:rPr b="0" lang="ja-JP" sz="7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テキスト ボックス 8"/>
          <p:cNvSpPr/>
          <p:nvPr/>
        </p:nvSpPr>
        <p:spPr>
          <a:xfrm>
            <a:off x="105120" y="2941560"/>
            <a:ext cx="343800" cy="16992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  <a:ea typeface="Arial"/>
              </a:rPr>
              <a:t>fosA3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9" name="直線矢印コネクタ 10"/>
          <p:cNvCxnSpPr/>
          <p:nvPr/>
        </p:nvCxnSpPr>
        <p:spPr>
          <a:xfrm>
            <a:off x="228240" y="3090960"/>
            <a:ext cx="1080" cy="178200"/>
          </a:xfrm>
          <a:prstGeom prst="straightConnector1">
            <a:avLst/>
          </a:prstGeom>
          <a:ln w="648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60" name="正方形/長方形 11"/>
          <p:cNvSpPr/>
          <p:nvPr/>
        </p:nvSpPr>
        <p:spPr>
          <a:xfrm>
            <a:off x="38160" y="2408400"/>
            <a:ext cx="178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. S1C. pGSU10-3-3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1" name="図 13" descr=""/>
          <p:cNvPicPr/>
          <p:nvPr/>
        </p:nvPicPr>
        <p:blipFill>
          <a:blip r:embed="rId1"/>
          <a:stretch/>
        </p:blipFill>
        <p:spPr>
          <a:xfrm>
            <a:off x="0" y="3362400"/>
            <a:ext cx="6858000" cy="3782880"/>
          </a:xfrm>
          <a:prstGeom prst="rect">
            <a:avLst/>
          </a:prstGeom>
          <a:ln w="0">
            <a:noFill/>
          </a:ln>
        </p:spPr>
      </p:pic>
      <p:pic>
        <p:nvPicPr>
          <p:cNvPr id="62" name="図 15" descr=""/>
          <p:cNvPicPr/>
          <p:nvPr/>
        </p:nvPicPr>
        <p:blipFill>
          <a:blip r:embed="rId2"/>
          <a:stretch/>
        </p:blipFill>
        <p:spPr>
          <a:xfrm>
            <a:off x="33480" y="3278160"/>
            <a:ext cx="2074680" cy="138240"/>
          </a:xfrm>
          <a:prstGeom prst="rect">
            <a:avLst/>
          </a:prstGeom>
          <a:ln w="0">
            <a:noFill/>
          </a:ln>
        </p:spPr>
      </p:pic>
      <p:cxnSp>
        <p:nvCxnSpPr>
          <p:cNvPr id="63" name="直線矢印コネクタ 16"/>
          <p:cNvCxnSpPr/>
          <p:nvPr/>
        </p:nvCxnSpPr>
        <p:spPr>
          <a:xfrm>
            <a:off x="748800" y="3090960"/>
            <a:ext cx="1080" cy="178200"/>
          </a:xfrm>
          <a:prstGeom prst="straightConnector1">
            <a:avLst/>
          </a:prstGeom>
          <a:ln w="648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64" name="テキスト ボックス 7"/>
          <p:cNvSpPr/>
          <p:nvPr/>
        </p:nvSpPr>
        <p:spPr>
          <a:xfrm>
            <a:off x="591480" y="2941560"/>
            <a:ext cx="381960" cy="180360"/>
          </a:xfrm>
          <a:prstGeom prst="rect">
            <a:avLst/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500" spc="-1" strike="noStrike">
                <a:solidFill>
                  <a:srgbClr val="ffffff"/>
                </a:solidFill>
                <a:latin typeface="Arial"/>
                <a:ea typeface="Arial"/>
              </a:rPr>
              <a:t>bla</a:t>
            </a:r>
            <a:r>
              <a:rPr b="1" lang="en-US" sz="500" spc="-1" strike="noStrike" baseline="-25000">
                <a:solidFill>
                  <a:srgbClr val="ffffff"/>
                </a:solidFill>
                <a:latin typeface="Arial"/>
                <a:ea typeface="Arial"/>
              </a:rPr>
              <a:t>KPC-2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正方形/長方形 1"/>
          <p:cNvSpPr/>
          <p:nvPr/>
        </p:nvSpPr>
        <p:spPr>
          <a:xfrm>
            <a:off x="2394000" y="2914560"/>
            <a:ext cx="3429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GSU10-3-4 (10,060 bp in size) is </a:t>
            </a:r>
            <a:r>
              <a:rPr b="1" lang="en-US" sz="7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ColRNAI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replicon plasmid, and carries no remarkable ARGs and virulence. 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6" name="図 3" descr=""/>
          <p:cNvPicPr/>
          <p:nvPr/>
        </p:nvPicPr>
        <p:blipFill>
          <a:blip r:embed="rId1"/>
          <a:stretch/>
        </p:blipFill>
        <p:spPr>
          <a:xfrm>
            <a:off x="0" y="3309840"/>
            <a:ext cx="6858000" cy="3738600"/>
          </a:xfrm>
          <a:prstGeom prst="rect">
            <a:avLst/>
          </a:prstGeom>
          <a:ln w="0">
            <a:noFill/>
          </a:ln>
        </p:spPr>
      </p:pic>
      <p:pic>
        <p:nvPicPr>
          <p:cNvPr id="67" name="図 5" descr=""/>
          <p:cNvPicPr/>
          <p:nvPr/>
        </p:nvPicPr>
        <p:blipFill>
          <a:blip r:embed="rId2"/>
          <a:stretch/>
        </p:blipFill>
        <p:spPr>
          <a:xfrm>
            <a:off x="23760" y="3201840"/>
            <a:ext cx="2048040" cy="111240"/>
          </a:xfrm>
          <a:prstGeom prst="rect">
            <a:avLst/>
          </a:prstGeom>
          <a:ln w="0">
            <a:noFill/>
          </a:ln>
        </p:spPr>
      </p:pic>
      <p:sp>
        <p:nvSpPr>
          <p:cNvPr id="68" name="正方形/長方形 6"/>
          <p:cNvSpPr/>
          <p:nvPr/>
        </p:nvSpPr>
        <p:spPr>
          <a:xfrm>
            <a:off x="38160" y="2416320"/>
            <a:ext cx="178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. S1D. pGSU10-3-4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5-14T07:28:48Z</dcterms:created>
  <dc:creator>黒田誠</dc:creator>
  <dc:description/>
  <dc:language>en-US</dc:language>
  <cp:lastModifiedBy>黒田誠</cp:lastModifiedBy>
  <cp:lastPrinted>2018-05-31T10:56:31Z</cp:lastPrinted>
  <dcterms:modified xsi:type="dcterms:W3CDTF">2018-06-06T23:59:12Z</dcterms:modified>
  <cp:revision>37</cp:revision>
  <dc:subject/>
  <dc:title>PowerPoint プレゼンテーション</dc:title>
</cp:coreProperties>
</file>